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327"/>
  </p:normalViewPr>
  <p:slideViewPr>
    <p:cSldViewPr snapToGrid="0">
      <p:cViewPr varScale="1">
        <p:scale>
          <a:sx n="124" d="100"/>
          <a:sy n="124" d="100"/>
        </p:scale>
        <p:origin x="54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8215FC-D5AA-5993-8A16-EA80E56FF8D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C9853E9-97EB-0A15-18FB-26994B91150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33EFAD-20D2-3E4D-0CB2-B65F27EE27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42408-3D65-C942-81AB-24B69128C7A7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16C27E-3AAE-FA41-CD3C-B4483C1782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3C69C6-ECCD-A935-6812-D8298C7F17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7D87C-CDA8-4943-AB15-D5E42BD08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26822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755A83-FE2B-FE03-0510-F55183FF3B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FF1FC13-66B9-AC6F-97DC-4E05E70DA85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EE500B-FDB7-E797-A67C-D7FFF0A58B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42408-3D65-C942-81AB-24B69128C7A7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A27927-CED2-7C7D-7F51-8A55833B0D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64D7B8-4C64-EF45-C735-D62B657EAA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7D87C-CDA8-4943-AB15-D5E42BD08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1406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21AA3B5-A34F-1205-FC6F-F52663E05D0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FD81727-F6A4-0AA4-C018-D4559461C9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E5EF66-FF31-CC28-3232-BA89789AE9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42408-3D65-C942-81AB-24B69128C7A7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568EC7-80FE-0AE8-9C7B-66086FB45A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8C4572-865E-15A2-2EFE-14AB16FE5D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7D87C-CDA8-4943-AB15-D5E42BD08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15401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1788D9-A3B1-8E36-203E-B320879737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3C1BAB-C05D-4F19-BE25-C3A5CBDFA1E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3F1C09-E75B-DFEA-C527-7A8A2FF204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42408-3D65-C942-81AB-24B69128C7A7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E41D74-7328-0D5A-803B-D7648CCA90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129442-76EC-5122-8990-D6F7B3C261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7D87C-CDA8-4943-AB15-D5E42BD08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68614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3B3EBC-92B6-7944-F117-827E932C0C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D213F2-6FFE-FFCB-E39E-E483A41C6E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7795EA-CA61-A568-AFD5-E1A7FF768D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42408-3D65-C942-81AB-24B69128C7A7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F192EC-554B-B97E-BDBA-EDB7FE462D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F421AA-13A2-E1CB-0821-C9ED4BCBD3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7D87C-CDA8-4943-AB15-D5E42BD08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70473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0596C2-0BC0-E269-363C-D3A26835BA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915819-75AC-C2B7-8FF9-D0DB516E9B9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66168C4-ED12-7CC4-197D-64E918598F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0D9D31A-AFF9-CB7F-865A-8EE20491E4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42408-3D65-C942-81AB-24B69128C7A7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FCD205-A40D-C626-91F4-C3CC296887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4FC1CDA-6E71-1465-F540-F0EF261772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7D87C-CDA8-4943-AB15-D5E42BD08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4720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11D344-FCDF-E086-A9C2-F12D41F073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09AEFF-7DAC-D2E0-4A38-13D8EA0951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01B07CA-C896-25DA-B7D1-BDABAACE0A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F1CFA91-64F7-3B30-6B44-4EA3822BC05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A6F130B-6212-0698-E44C-7A01DE3990E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51DA972-D820-98B9-A5CD-1231A59F81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42408-3D65-C942-81AB-24B69128C7A7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CE25D22-63F6-8EE6-6090-F036D8EB07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650CFA5-6A9E-D578-5C20-FA7029BC7E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7D87C-CDA8-4943-AB15-D5E42BD08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12566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5B18E1-8849-8D7E-9851-FDB288B40E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BE80FED-5F4E-4C39-E7FC-61A18319FA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42408-3D65-C942-81AB-24B69128C7A7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7833EC7-F106-EE52-CAB1-85BA8E9A4D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62D39E1-13E8-05CC-7569-70C612E83E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7D87C-CDA8-4943-AB15-D5E42BD08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74932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C3BD332-F11B-DEF5-3B7D-954809E718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42408-3D65-C942-81AB-24B69128C7A7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0210B9E-A5FD-0E44-074C-0AC462EF31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88D3B6F-953A-7F55-CB78-2A31A891B6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7D87C-CDA8-4943-AB15-D5E42BD08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01387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0257BE-A49D-689D-EBAD-032D5C71FD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C968FD-AF29-FE55-D2C3-CCE56D99FF1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7D10D81-F0E7-3ABB-6857-D32BC06B51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C5E8C7-18C1-A051-7D7E-CAA44BAE08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42408-3D65-C942-81AB-24B69128C7A7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89B7F77-D74E-1CC6-2E23-655A6A41B7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879131-E655-9DC2-FFD8-0790218A83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7D87C-CDA8-4943-AB15-D5E42BD08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74709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97888E-387C-52FB-1C95-2CCF710146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D80D3A6-72DC-C2DB-349B-524B667D99F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787484B-0E68-77D1-455A-92E097E88E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C0E7D24-DA3B-8D30-2DDD-6D941EFA06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42408-3D65-C942-81AB-24B69128C7A7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FD5FA7A-2AD9-2CED-8FD6-7E4C6C854C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257B46A-CE5F-B39D-FFF5-CA3675A6EB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7D87C-CDA8-4943-AB15-D5E42BD08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57884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C8813B7-2EB2-6D2E-8D93-A0C9B00244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A9400B-F2DE-4A82-B6B3-5E48465301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8032EE-8366-1F60-DB68-DB2647B885F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F42408-3D65-C942-81AB-24B69128C7A7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797BE2-5DE2-4031-8733-E53C997C6C6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7AF6CE-984D-3847-E2D9-2E2BB721771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57D87C-CDA8-4943-AB15-D5E42BD08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28883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17E78B07-7D07-A51A-21AD-979F2445545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99731943"/>
              </p:ext>
            </p:extLst>
          </p:nvPr>
        </p:nvGraphicFramePr>
        <p:xfrm>
          <a:off x="1047390" y="708917"/>
          <a:ext cx="2363631" cy="5120640"/>
        </p:xfrm>
        <a:graphic>
          <a:graphicData uri="http://schemas.openxmlformats.org/drawingml/2006/table">
            <a:tbl>
              <a:tblPr/>
              <a:tblGrid>
                <a:gridCol w="550690">
                  <a:extLst>
                    <a:ext uri="{9D8B030D-6E8A-4147-A177-3AD203B41FA5}">
                      <a16:colId xmlns:a16="http://schemas.microsoft.com/office/drawing/2014/main" val="3547997200"/>
                    </a:ext>
                  </a:extLst>
                </a:gridCol>
                <a:gridCol w="1812941">
                  <a:extLst>
                    <a:ext uri="{9D8B030D-6E8A-4147-A177-3AD203B41FA5}">
                      <a16:colId xmlns:a16="http://schemas.microsoft.com/office/drawing/2014/main" val="1590582246"/>
                    </a:ext>
                  </a:extLst>
                </a:gridCol>
              </a:tblGrid>
              <a:tr h="96696">
                <a:tc>
                  <a:txBody>
                    <a:bodyPr/>
                    <a:lstStyle/>
                    <a:p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</a:rPr>
                        <a:t>Metal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</a:rPr>
                        <a:t>Target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250701"/>
                  </a:ext>
                </a:extLst>
              </a:tr>
              <a:tr h="96696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41Pr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  <a:latin typeface="Symbol" pitchFamily="2" charset="2"/>
                        </a:rPr>
                        <a:t>a</a:t>
                      </a:r>
                      <a:r>
                        <a:rPr lang="en-GB" sz="1200" dirty="0">
                          <a:effectLst/>
                          <a:latin typeface="Calibri" panose="020F0502020204030204" pitchFamily="34" charset="0"/>
                        </a:rPr>
                        <a:t>SMA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9339648"/>
                  </a:ext>
                </a:extLst>
              </a:tr>
              <a:tr h="96696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42Nd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CD56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92174847"/>
                  </a:ext>
                </a:extLst>
              </a:tr>
              <a:tr h="96696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43Nd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Vimentin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1994502"/>
                  </a:ext>
                </a:extLst>
              </a:tr>
              <a:tr h="96696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44Nd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EpCAM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083392"/>
                  </a:ext>
                </a:extLst>
              </a:tr>
              <a:tr h="193393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45Nd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br>
                        <a:rPr lang="en-GB" sz="1200" dirty="0"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en-GB" sz="1200" dirty="0"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8806481"/>
                  </a:ext>
                </a:extLst>
              </a:tr>
              <a:tr h="96696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46Nd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CD16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3082385"/>
                  </a:ext>
                </a:extLst>
              </a:tr>
              <a:tr h="96696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47Sm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  <a:latin typeface="Calibri" panose="020F0502020204030204" pitchFamily="34" charset="0"/>
                        </a:rPr>
                        <a:t>CD64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4160937"/>
                  </a:ext>
                </a:extLst>
              </a:tr>
              <a:tr h="96696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48 Nd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Pan Keratin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1567959"/>
                  </a:ext>
                </a:extLst>
              </a:tr>
              <a:tr h="96696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49Sm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CD15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4092683"/>
                  </a:ext>
                </a:extLst>
              </a:tr>
              <a:tr h="96696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50Nd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TMPRSS2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6444011"/>
                  </a:ext>
                </a:extLst>
              </a:tr>
              <a:tr h="96696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51Eu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CD200R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9702707"/>
                  </a:ext>
                </a:extLst>
              </a:tr>
              <a:tr h="96696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52Sm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Pan membrane*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9886"/>
                  </a:ext>
                </a:extLst>
              </a:tr>
              <a:tr h="96696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53Eu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  <a:latin typeface="Calibri" panose="020F0502020204030204" pitchFamily="34" charset="0"/>
                        </a:rPr>
                        <a:t>V</a:t>
                      </a:r>
                      <a:r>
                        <a:rPr lang="en-GB" sz="1200" dirty="0">
                          <a:effectLst/>
                          <a:latin typeface="Symbol" pitchFamily="2" charset="2"/>
                        </a:rPr>
                        <a:t>a</a:t>
                      </a:r>
                      <a:r>
                        <a:rPr lang="en-GB" sz="1200" dirty="0">
                          <a:effectLst/>
                          <a:latin typeface="Calibri" panose="020F0502020204030204" pitchFamily="34" charset="0"/>
                        </a:rPr>
                        <a:t>7.2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067264"/>
                  </a:ext>
                </a:extLst>
              </a:tr>
              <a:tr h="96696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54Sm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CD45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1323333"/>
                  </a:ext>
                </a:extLst>
              </a:tr>
              <a:tr h="96696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55Gd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FoxP3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7422363"/>
                  </a:ext>
                </a:extLst>
              </a:tr>
              <a:tr h="96696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56Gd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CD4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0731902"/>
                  </a:ext>
                </a:extLst>
              </a:tr>
              <a:tr h="193393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57Gd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br>
                        <a:rPr lang="en-GB" sz="1200" dirty="0"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en-GB" sz="1200" dirty="0"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68116477"/>
                  </a:ext>
                </a:extLst>
              </a:tr>
              <a:tr h="96696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58Gd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Ecadherin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0941484"/>
                  </a:ext>
                </a:extLst>
              </a:tr>
              <a:tr h="96696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59Tb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CD68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154462"/>
                  </a:ext>
                </a:extLst>
              </a:tr>
              <a:tr h="96696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60Gd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PF4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938998"/>
                  </a:ext>
                </a:extLst>
              </a:tr>
              <a:tr h="96696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61Dy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CD20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293791"/>
                  </a:ext>
                </a:extLst>
              </a:tr>
              <a:tr h="96696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62Dy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CD8a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7497101"/>
                  </a:ext>
                </a:extLst>
              </a:tr>
              <a:tr h="96696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63Dy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CD14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966374"/>
                  </a:ext>
                </a:extLst>
              </a:tr>
              <a:tr h="96696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64Dy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CD161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4529479"/>
                  </a:ext>
                </a:extLst>
              </a:tr>
              <a:tr h="96696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65Ho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  <a:latin typeface="Calibri" panose="020F0502020204030204" pitchFamily="34" charset="0"/>
                        </a:rPr>
                        <a:t>ACE2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5252307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147EA0DF-9871-068A-EAE6-F59A473CA2A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79889506"/>
              </p:ext>
            </p:extLst>
          </p:nvPr>
        </p:nvGraphicFramePr>
        <p:xfrm>
          <a:off x="3591674" y="708917"/>
          <a:ext cx="2363631" cy="3302353"/>
        </p:xfrm>
        <a:graphic>
          <a:graphicData uri="http://schemas.openxmlformats.org/drawingml/2006/table">
            <a:tbl>
              <a:tblPr/>
              <a:tblGrid>
                <a:gridCol w="550690">
                  <a:extLst>
                    <a:ext uri="{9D8B030D-6E8A-4147-A177-3AD203B41FA5}">
                      <a16:colId xmlns:a16="http://schemas.microsoft.com/office/drawing/2014/main" val="2777064875"/>
                    </a:ext>
                  </a:extLst>
                </a:gridCol>
                <a:gridCol w="1812941">
                  <a:extLst>
                    <a:ext uri="{9D8B030D-6E8A-4147-A177-3AD203B41FA5}">
                      <a16:colId xmlns:a16="http://schemas.microsoft.com/office/drawing/2014/main" val="3276848136"/>
                    </a:ext>
                  </a:extLst>
                </a:gridCol>
              </a:tblGrid>
              <a:tr h="193393">
                <a:tc>
                  <a:txBody>
                    <a:bodyPr/>
                    <a:lstStyle/>
                    <a:p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</a:rPr>
                        <a:t>Metal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</a:rPr>
                        <a:t>Target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5067028"/>
                  </a:ext>
                </a:extLst>
              </a:tr>
              <a:tr h="193393"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  <a:latin typeface="Calibri" panose="020F0502020204030204" pitchFamily="34" charset="0"/>
                        </a:rPr>
                        <a:t>166Er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br>
                        <a:rPr lang="en-GB" sz="1200" dirty="0"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en-GB" sz="1200" dirty="0"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5278837"/>
                  </a:ext>
                </a:extLst>
              </a:tr>
              <a:tr h="96696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67Er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  <a:latin typeface="Calibri" panose="020F0502020204030204" pitchFamily="34" charset="0"/>
                        </a:rPr>
                        <a:t>Granzyme B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1920095"/>
                  </a:ext>
                </a:extLst>
              </a:tr>
              <a:tr h="96696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68Er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  <a:latin typeface="Calibri" panose="020F0502020204030204" pitchFamily="34" charset="0"/>
                        </a:rPr>
                        <a:t>Ki67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3805392"/>
                  </a:ext>
                </a:extLst>
              </a:tr>
              <a:tr h="96696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69Tm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  <a:latin typeface="Calibri" panose="020F0502020204030204" pitchFamily="34" charset="0"/>
                        </a:rPr>
                        <a:t>Collagen I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02458244"/>
                  </a:ext>
                </a:extLst>
              </a:tr>
              <a:tr h="96696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70Er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  <a:latin typeface="Calibri" panose="020F0502020204030204" pitchFamily="34" charset="0"/>
                        </a:rPr>
                        <a:t>CD3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3835090"/>
                  </a:ext>
                </a:extLst>
              </a:tr>
              <a:tr h="96696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71Yb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  <a:latin typeface="Calibri" panose="020F0502020204030204" pitchFamily="34" charset="0"/>
                        </a:rPr>
                        <a:t>Histone 3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6299001"/>
                  </a:ext>
                </a:extLst>
              </a:tr>
              <a:tr h="96696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72Yb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  <a:latin typeface="Calibri" panose="020F0502020204030204" pitchFamily="34" charset="0"/>
                        </a:rPr>
                        <a:t>CD31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90204490"/>
                  </a:ext>
                </a:extLst>
              </a:tr>
              <a:tr h="96696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73Yb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  <a:latin typeface="Calibri" panose="020F0502020204030204" pitchFamily="34" charset="0"/>
                        </a:rPr>
                        <a:t>CD45RO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468108"/>
                  </a:ext>
                </a:extLst>
              </a:tr>
              <a:tr h="193393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74Yb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br>
                        <a:rPr lang="en-GB" sz="1200" dirty="0"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en-GB" sz="1200" dirty="0"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5563207"/>
                  </a:ext>
                </a:extLst>
              </a:tr>
              <a:tr h="193393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75Lu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br>
                        <a:rPr lang="en-GB" sz="1200" dirty="0"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en-GB" sz="1200" dirty="0"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4357952"/>
                  </a:ext>
                </a:extLst>
              </a:tr>
              <a:tr h="193393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76Yb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  <a:latin typeface="Calibri" panose="020F0502020204030204" pitchFamily="34" charset="0"/>
                        </a:rPr>
                        <a:t>-</a:t>
                      </a:r>
                      <a:br>
                        <a:rPr lang="en-GB" sz="1200" dirty="0">
                          <a:effectLst/>
                          <a:latin typeface="Calibri" panose="020F0502020204030204" pitchFamily="34" charset="0"/>
                        </a:rPr>
                      </a:br>
                      <a:endParaRPr lang="en-GB" sz="12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9183284"/>
                  </a:ext>
                </a:extLst>
              </a:tr>
              <a:tr h="96696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91Ir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  <a:latin typeface="Calibri" panose="020F0502020204030204" pitchFamily="34" charset="0"/>
                        </a:rPr>
                        <a:t>DNA dye 1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297746"/>
                  </a:ext>
                </a:extLst>
              </a:tr>
              <a:tr h="96696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  <a:latin typeface="Calibri" panose="020F0502020204030204" pitchFamily="34" charset="0"/>
                        </a:rPr>
                        <a:t>193Ir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  <a:latin typeface="Calibri" panose="020F0502020204030204" pitchFamily="34" charset="0"/>
                        </a:rPr>
                        <a:t>DNA dye 3</a:t>
                      </a:r>
                    </a:p>
                  </a:txBody>
                  <a:tcPr marL="16788" marR="16788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9066770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B2D1DEEA-27DC-FFBB-D38E-486257901FE5}"/>
              </a:ext>
            </a:extLst>
          </p:cNvPr>
          <p:cNvSpPr txBox="1"/>
          <p:nvPr/>
        </p:nvSpPr>
        <p:spPr>
          <a:xfrm>
            <a:off x="3591674" y="4119937"/>
            <a:ext cx="2370585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Table S5 </a:t>
            </a:r>
            <a:r>
              <a:rPr lang="en-US" sz="1400" dirty="0"/>
              <a:t>Panel 1 metal-tagged</a:t>
            </a:r>
          </a:p>
          <a:p>
            <a:r>
              <a:rPr lang="en-US" sz="1400" dirty="0"/>
              <a:t>antibody panel for sentinel</a:t>
            </a:r>
          </a:p>
          <a:p>
            <a:r>
              <a:rPr lang="en-US" sz="1400" dirty="0"/>
              <a:t>cohort</a:t>
            </a:r>
          </a:p>
        </p:txBody>
      </p:sp>
    </p:spTree>
    <p:extLst>
      <p:ext uri="{BB962C8B-B14F-4D97-AF65-F5344CB8AC3E}">
        <p14:creationId xmlns:p14="http://schemas.microsoft.com/office/powerpoint/2010/main" val="12703313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 2013 - 2022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07</Words>
  <Application>Microsoft Macintosh PowerPoint</Application>
  <PresentationFormat>Widescreen</PresentationFormat>
  <Paragraphs>8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 2013 - 2022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o, Ling-Pei (RTH) OUH</dc:creator>
  <cp:lastModifiedBy>Ho, Ling-Pei (RTH) OUH</cp:lastModifiedBy>
  <cp:revision>1</cp:revision>
  <dcterms:created xsi:type="dcterms:W3CDTF">2022-12-20T14:07:10Z</dcterms:created>
  <dcterms:modified xsi:type="dcterms:W3CDTF">2022-12-20T14:09:55Z</dcterms:modified>
</cp:coreProperties>
</file>